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7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216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336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253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576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684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77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650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816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609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212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726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2F875-A008-FE41-B641-AA0EA27105DA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781E5-653C-F640-BFF2-809E50FBC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659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72A0BF7-F2A4-ED49-B2CC-6CC0C54ED75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67614" y="287595"/>
            <a:ext cx="2522772" cy="378415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A9D0CEC-1DEC-A741-90B8-F2C8CDD4C25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" y="4031431"/>
            <a:ext cx="6858000" cy="40341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FE4FF52-BF85-2D4D-8E59-C01B894D2F29}"/>
              </a:ext>
            </a:extLst>
          </p:cNvPr>
          <p:cNvSpPr txBox="1"/>
          <p:nvPr/>
        </p:nvSpPr>
        <p:spPr>
          <a:xfrm>
            <a:off x="2504560" y="8600022"/>
            <a:ext cx="203132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AE2771D-139E-F649-9289-86F3AE6A3446}"/>
              </a:ext>
            </a:extLst>
          </p:cNvPr>
          <p:cNvSpPr txBox="1"/>
          <p:nvPr/>
        </p:nvSpPr>
        <p:spPr>
          <a:xfrm>
            <a:off x="1785390" y="401566"/>
            <a:ext cx="338554" cy="369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8E02687-F6B2-A248-AC82-05A5ACF6E883}"/>
              </a:ext>
            </a:extLst>
          </p:cNvPr>
          <p:cNvSpPr txBox="1"/>
          <p:nvPr/>
        </p:nvSpPr>
        <p:spPr>
          <a:xfrm>
            <a:off x="171686" y="4220136"/>
            <a:ext cx="338554" cy="369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646789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3AA9487-DED3-D0A3-F32B-27FA30024EF1}"/>
              </a:ext>
            </a:extLst>
          </p:cNvPr>
          <p:cNvSpPr txBox="1"/>
          <p:nvPr/>
        </p:nvSpPr>
        <p:spPr>
          <a:xfrm>
            <a:off x="301487" y="422056"/>
            <a:ext cx="625502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3. VDR ATAC-Seq in African and European American Cell lines. A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ATAC-Seq was undertaken in triplicate in HPr1AR, LNCaP, RC43N and RC43T following 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Noto Sans Symbols"/>
              </a:rPr>
              <a:t>α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25(OH)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reatment (100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4h) or vehicle control. Motif enrichment in mono nucleosome regions was undertaken with </a:t>
            </a:r>
            <a:r>
              <a:rPr lang="en-US" sz="120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Homer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ranked by significance to visualize in descending significance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Frequency of enriched motifs by FOX family members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9742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84</Words>
  <Application>Microsoft Macintosh PowerPoint</Application>
  <PresentationFormat>Letter Paper (8.5x11 in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25:26Z</dcterms:created>
  <dcterms:modified xsi:type="dcterms:W3CDTF">2023-02-21T19:26:46Z</dcterms:modified>
</cp:coreProperties>
</file>